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72" r:id="rId1"/>
  </p:sldMasterIdLst>
  <p:sldIdLst>
    <p:sldId id="256" r:id="rId2"/>
  </p:sldIdLst>
  <p:sldSz cx="6858000" cy="6303963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8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419" y="45"/>
      </p:cViewPr>
      <p:guideLst>
        <p:guide orient="horz" pos="1986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tags" Target="../tags/tag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5" Type="http://schemas.openxmlformats.org/officeDocument/2006/relationships/tags" Target="../tags/tag6.xml"/><Relationship Id="rId4" Type="http://schemas.openxmlformats.org/officeDocument/2006/relationships/tags" Target="../tags/tag5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1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031691"/>
            <a:ext cx="5829300" cy="219471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311040"/>
            <a:ext cx="5143500" cy="1521998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82925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91936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35628"/>
            <a:ext cx="1478756" cy="53423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35628"/>
            <a:ext cx="4350544" cy="53423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30295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1429673"/>
            <a:ext cx="2943606" cy="423606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1429673"/>
            <a:ext cx="2940300" cy="423606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4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711527"/>
            <a:ext cx="6172200" cy="5040256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2283506"/>
            <a:ext cx="5512050" cy="936567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3273023"/>
            <a:ext cx="5512050" cy="4335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477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571615"/>
            <a:ext cx="5915025" cy="262227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218696"/>
            <a:ext cx="5915025" cy="1378991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5694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678138"/>
            <a:ext cx="2914650" cy="399980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678138"/>
            <a:ext cx="2914650" cy="399980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6892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5629"/>
            <a:ext cx="5915025" cy="121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545347"/>
            <a:ext cx="2901255" cy="75735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302698"/>
            <a:ext cx="2901255" cy="338692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545347"/>
            <a:ext cx="2915543" cy="75735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302698"/>
            <a:ext cx="2915543" cy="338692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547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578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636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0264"/>
            <a:ext cx="2211884" cy="147092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907655"/>
            <a:ext cx="3471863" cy="44799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91189"/>
            <a:ext cx="2211884" cy="350366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49000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0264"/>
            <a:ext cx="2211884" cy="147092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907655"/>
            <a:ext cx="3471863" cy="44799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91189"/>
            <a:ext cx="2211884" cy="350366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4/19</a:t>
            </a:fld>
            <a:endParaRPr lang="zh-CN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564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35629"/>
            <a:ext cx="5915025" cy="1218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678138"/>
            <a:ext cx="5915025" cy="39998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842841"/>
            <a:ext cx="1543050" cy="3356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842841"/>
            <a:ext cx="2314575" cy="3356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842841"/>
            <a:ext cx="1543050" cy="3356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03254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56" r:id="rId12"/>
    <p:sldLayoutId id="2147483658" r:id="rId13"/>
    <p:sldLayoutId id="2147483659" r:id="rId14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CIBERSORT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0005" y="260781"/>
            <a:ext cx="6858000" cy="5625465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>
            <a:off x="186690" y="5886246"/>
            <a:ext cx="64846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Figure S3. Cell proportion estimated by CIBERSORT analysis</a:t>
            </a:r>
            <a:r>
              <a:rPr lang="en-US" altLang="zh-CN" sz="1000" dirty="0"/>
              <a:t>. Cells proportion was calculated based on single cell </a:t>
            </a:r>
            <a:r>
              <a:rPr lang="en-US" altLang="zh-CN" sz="1000" dirty="0" err="1"/>
              <a:t>RNAseq</a:t>
            </a:r>
            <a:r>
              <a:rPr lang="en-US" altLang="zh-CN" sz="1000" dirty="0"/>
              <a:t> data and a widely used leukocyte signature matrix LM22. </a:t>
            </a:r>
            <a:r>
              <a:rPr lang="en-US" altLang="zh-CN" sz="1000" i="1" dirty="0"/>
              <a:t>P</a:t>
            </a:r>
            <a:r>
              <a:rPr lang="en-US" altLang="zh-CN" sz="1000" dirty="0"/>
              <a:t> value was calculated by Wilcoxon rank-sum test.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A1B45C6E-5F3B-4D2F-BED5-C2543563B597}"/>
              </a:ext>
            </a:extLst>
          </p:cNvPr>
          <p:cNvSpPr/>
          <p:nvPr/>
        </p:nvSpPr>
        <p:spPr>
          <a:xfrm>
            <a:off x="-40005" y="30911"/>
            <a:ext cx="6703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/>
              <a:t>Figure S3</a:t>
            </a:r>
            <a:endParaRPr lang="zh-CN" altLang="en-US" sz="1000" b="1" dirty="0"/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2M4YjUxY2M4M2U4MDM4NzcxYTU5OTI3YjQzNWM4ZTE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Office PowerPoint</Application>
  <PresentationFormat>自定义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Derek</cp:lastModifiedBy>
  <cp:revision>160</cp:revision>
  <dcterms:created xsi:type="dcterms:W3CDTF">2019-06-19T02:08:00Z</dcterms:created>
  <dcterms:modified xsi:type="dcterms:W3CDTF">2023-04-19T13:54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89687F036D3648A0B1505B54B61EBF49</vt:lpwstr>
  </property>
</Properties>
</file>